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532E3-1092-4CBE-89C1-A7AD7C7DF0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0842E-C5C7-4476-922B-0D62D3E8E8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85B33-981D-49F9-82D5-197CE5D0C7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E451E5-666C-455D-93C5-96417445BB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1424975-7290-4559-9A02-20EDF84A48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661CED6-02DD-4DBD-B775-6ACB2E8F39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F9A4BA-BA58-4D64-9F0A-ED26B176BA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D100973-B692-4763-A4CF-CC872C734C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BF6F2A4-1313-43A7-B0E9-7609BBF555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C32F9C-4C5A-4BD6-BC2C-EC8E65F7B7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8DFDFA0-8658-485A-B4D7-31A6E6E0DF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AF082-5A48-4EAC-964B-4FB1A87813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E7C2255-35EC-48E2-865C-D17986FA44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CAAF1D4-550C-4E3D-97F8-F14FE8102E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C6440D9-1347-4F9B-B719-85DE4DD9C5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F1B4E34-1C7A-4417-A98F-0C1CD60B5D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39538D4-7801-4E6D-A1BB-910B665DAA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F6D3D-2A90-4C49-BB83-0A316C930C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95C9E-AE65-4693-854A-5DD7C1863B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38A27-74E2-4192-8377-1BF9D7D0B9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5B8F4-F729-44C5-914A-110A61B857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A8FCB-AB75-4BB3-BA3B-DA2339B30E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F89DC-8C0A-4E87-8A8C-CB8E37F1A9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79721-E7F5-463E-A6CF-EFF1762102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1B7C2D-6C4F-4D01-8336-7FF0CE3CE06B}" type="slidenum"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8CC53B-6922-4EA4-921C-B626C050C73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1"/>
          <p:cNvSpPr/>
          <p:nvPr/>
        </p:nvSpPr>
        <p:spPr>
          <a:xfrm>
            <a:off x="0" y="-36360"/>
            <a:ext cx="2830680" cy="68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1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3" name=""/>
          <p:cNvGraphicFramePr/>
          <p:nvPr/>
        </p:nvGraphicFramePr>
        <p:xfrm>
          <a:off x="457200" y="646200"/>
          <a:ext cx="8229600" cy="5557680"/>
        </p:xfrm>
        <a:graphic>
          <a:graphicData uri="http://schemas.openxmlformats.org/drawingml/2006/table">
            <a:tbl>
              <a:tblPr/>
              <a:tblGrid>
                <a:gridCol w="1670040"/>
                <a:gridCol w="6559560"/>
              </a:tblGrid>
              <a:tr h="16200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KN2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yclin-dependent kinase inhibitor 2A (melanoma, p16, inhibits CDK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B3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B3B, member RAS oncogene famil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CB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clear cap binding protein subunit 2, 20kD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D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sicle docking protein p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9A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lagen, type IX, alpha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ITL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IT liga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PFIB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TPRF interacting protein, binding protein 1 (liprin beta 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EF1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ukaryotic translation elongation factor 1 delta (guanine nucleotide exchange protei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M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amin A/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AZ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rnithine decarboxylase antizyme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AR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creted protein, acidic, cysteine-rich (osteonecti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HIT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owth hormone inducible transmembrane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P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cleoporin 62kD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NX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orting nexin 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V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veolin 1, caveolae protein, 22kD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PT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umor protein, translationally-controlled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S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sparagine synthet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IF5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ukaryotic translation initiation factor 5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KSG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poptosis inhibit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RP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gnal recognition particle receptor ('docking protein'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LL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lladin, cytoskeletal associated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MEM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ansmembrane protein 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ment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R2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clear receptor subfamily 2, group F, member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VL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shevelled, dsh homolog 1 (Drosophil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GF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ascular endothelial growth factor 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lomerase-associated protei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XBP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yntaxin binding protein 6 (amisy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100A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100 calcium binding protein A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ung cancer metastasis-associated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FKBI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clear factor of kappa light polypeptide gene enhancer in B-cells inhibitor, alph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NFRSF6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umor necrosis factor receptor superfamily, member 6b, deco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1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EF1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ukaryotic translation elongation factor 1 delta (guanine nucleotide exchange protei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AM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AM metallopeptidase domain 19 (meltrin bet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N, member RAS oncogene famil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13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lagen, type XIII, alpha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F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ypoxia-inducible factor 1, alpha subunit (basic helix-loop-helix transcription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HO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s homolog gene family, member 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7:09Z</dcterms:modified>
  <cp:revision>257</cp:revision>
  <dc:subject/>
  <dc:title>Diapositiva 1</dc:title>
</cp:coreProperties>
</file>